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7" r:id="rId3"/>
    <p:sldId id="258" r:id="rId4"/>
    <p:sldId id="259" r:id="rId5"/>
    <p:sldId id="256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864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036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601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850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65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414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273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824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848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453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366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530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-1"/>
            <a:ext cx="9601201" cy="6744139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102E1-F374-4BE7-AF01-2AF768D3FF3A}" type="datetimeFigureOut">
              <a:rPr lang="en-US" smtClean="0"/>
              <a:t>3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B9088-9060-4AD6-8501-3FCFDB9CBDF3}" type="slidenum">
              <a:rPr lang="en-US" smtClean="0"/>
              <a:t>‹#›</a:t>
            </a:fld>
            <a:endParaRPr lang="en-US"/>
          </a:p>
        </p:txBody>
      </p:sp>
      <p:grpSp>
        <p:nvGrpSpPr>
          <p:cNvPr id="8" name="Group 7"/>
          <p:cNvGrpSpPr/>
          <p:nvPr userDrawn="1"/>
        </p:nvGrpSpPr>
        <p:grpSpPr>
          <a:xfrm>
            <a:off x="6948264" y="-162878"/>
            <a:ext cx="2592288" cy="999590"/>
            <a:chOff x="6948264" y="-162878"/>
            <a:chExt cx="2592288" cy="999590"/>
          </a:xfrm>
        </p:grpSpPr>
        <p:sp>
          <p:nvSpPr>
            <p:cNvPr id="9" name="Rectangle 8"/>
            <p:cNvSpPr/>
            <p:nvPr userDrawn="1"/>
          </p:nvSpPr>
          <p:spPr>
            <a:xfrm>
              <a:off x="6948264" y="-162878"/>
              <a:ext cx="2592288" cy="999590"/>
            </a:xfrm>
            <a:prstGeom prst="rect">
              <a:avLst/>
            </a:prstGeom>
            <a:solidFill>
              <a:schemeClr val="bg1">
                <a:alpha val="80000"/>
              </a:schemeClr>
            </a:solidFill>
            <a:ln>
              <a:noFill/>
            </a:ln>
            <a:effectLst>
              <a:softEdge rad="3175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94368" y="186180"/>
              <a:ext cx="1804408" cy="30147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76285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1" kern="1200">
          <a:solidFill>
            <a:schemeClr val="tx1">
              <a:lumMod val="85000"/>
              <a:lumOff val="15000"/>
            </a:schemeClr>
          </a:solidFill>
          <a:latin typeface="Myriad Pro" pitchFamily="34" charset="0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Myriad Pro" pitchFamily="34" charset="0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Myriad Pro" pitchFamily="34" charset="0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Myriad Pro" pitchFamily="34" charset="0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Myriad Pro" pitchFamily="34" charset="0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Myriad Pro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://www.dementiaguide.com/symptomguide/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CA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Multimedia Appendix 1</a:t>
            </a:r>
            <a:endParaRPr lang="en-US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4" name="Subtitle 3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62500" lnSpcReduction="20000"/>
          </a:bodyPr>
          <a:lstStyle/>
          <a:p>
            <a:r>
              <a:rPr lang="en-CA" sz="51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SymptomGuide</a:t>
            </a:r>
            <a:r>
              <a:rPr lang="en-CA" sz="5100" baseline="30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TM</a:t>
            </a:r>
            <a:r>
              <a:rPr lang="en-CA" sz="51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 Screenshots</a:t>
            </a:r>
          </a:p>
          <a:p>
            <a:endParaRPr lang="en-CA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endParaRPr lang="en-CA" dirty="0" smtClean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r>
              <a:rPr lang="en-CA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Source URL: </a:t>
            </a:r>
            <a:r>
              <a:rPr lang="en-CA" dirty="0" smtClean="0">
                <a:solidFill>
                  <a:schemeClr val="tx1">
                    <a:lumMod val="75000"/>
                    <a:lumOff val="25000"/>
                  </a:schemeClr>
                </a:solidFill>
                <a:hlinkClick r:id="rId2"/>
              </a:rPr>
              <a:t>www.dementiaguide.com/symptomguide/</a:t>
            </a:r>
            <a:endParaRPr lang="en-CA" dirty="0" smtClean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r>
              <a:rPr lang="en-CA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Taken on March 6, 2013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4103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CA" dirty="0" smtClean="0"/>
              <a:t>SymptomGuide</a:t>
            </a:r>
            <a:r>
              <a:rPr lang="en-CA" baseline="30000" dirty="0" smtClean="0"/>
              <a:t>TM</a:t>
            </a:r>
            <a:r>
              <a:rPr lang="en-CA" dirty="0" smtClean="0"/>
              <a:t> Portal </a:t>
            </a:r>
            <a:endParaRPr lang="en-US" dirty="0"/>
          </a:p>
        </p:txBody>
      </p:sp>
      <p:pic>
        <p:nvPicPr>
          <p:cNvPr id="5" name="Picture 5" descr="C:\Users\Amanda\Documents\Abstracts &amp; Publications\JAI #2 Nov 2012\REsubmission March 6\Revision February 2013\Screen shots\Symptom Profile Overview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1371600"/>
            <a:ext cx="7691708" cy="54413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61057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C:\Users\Amanda\Documents\Abstracts &amp; Publications\JAI #2 Nov 2012\REsubmission March 6\Revision February 2013\Screen shots\Care Profile Page 1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82" b="2401"/>
          <a:stretch/>
        </p:blipFill>
        <p:spPr bwMode="auto">
          <a:xfrm>
            <a:off x="1944710" y="1736500"/>
            <a:ext cx="5275262" cy="5121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810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CA" dirty="0" smtClean="0"/>
              <a:t>SymptomGuide</a:t>
            </a:r>
            <a:r>
              <a:rPr lang="en-CA" baseline="30000" dirty="0" smtClean="0"/>
              <a:t>TM</a:t>
            </a:r>
            <a:r>
              <a:rPr lang="en-CA" dirty="0" smtClean="0"/>
              <a:t> Health Status Sample Inform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17038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3048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CA" dirty="0" smtClean="0"/>
              <a:t>SymptomGuide</a:t>
            </a:r>
            <a:r>
              <a:rPr lang="en-CA" baseline="30000" dirty="0" smtClean="0"/>
              <a:t>TM</a:t>
            </a:r>
            <a:r>
              <a:rPr lang="en-CA" dirty="0" smtClean="0"/>
              <a:t> </a:t>
            </a:r>
            <a:br>
              <a:rPr lang="en-CA" dirty="0" smtClean="0"/>
            </a:br>
            <a:r>
              <a:rPr lang="en-CA" dirty="0" smtClean="0"/>
              <a:t>Symptom Selection</a:t>
            </a:r>
            <a:endParaRPr lang="en-US" dirty="0"/>
          </a:p>
        </p:txBody>
      </p:sp>
      <p:pic>
        <p:nvPicPr>
          <p:cNvPr id="3" name="Picture 3" descr="C:\Users\Amanda\Documents\Abstracts &amp; Publications\JAI #2 Nov 2012\REsubmission March 6\Revision February 2013\Screen shots\Add Symptom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1446283"/>
            <a:ext cx="6248400" cy="53953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087811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CA" b="1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Myriad Pro" pitchFamily="34" charset="0"/>
              </a:rPr>
              <a:t>SymptomGuide</a:t>
            </a:r>
            <a:r>
              <a:rPr lang="en-CA" b="1" baseline="30000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Myriad Pro" pitchFamily="34" charset="0"/>
              </a:rPr>
              <a:t>TM </a:t>
            </a:r>
            <a:br>
              <a:rPr lang="en-CA" b="1" baseline="30000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Myriad Pro" pitchFamily="34" charset="0"/>
              </a:rPr>
            </a:br>
            <a:r>
              <a:rPr lang="en-CA" b="1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Myriad Pro" pitchFamily="34" charset="0"/>
              </a:rPr>
              <a:t>S</a:t>
            </a:r>
            <a:r>
              <a:rPr lang="en-CA" b="1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Myriad Pro" pitchFamily="34" charset="0"/>
              </a:rPr>
              <a:t>ymptom Descriptors </a:t>
            </a:r>
            <a:endParaRPr lang="en-US" b="1" baseline="30000" dirty="0">
              <a:solidFill>
                <a:schemeClr val="tx1">
                  <a:lumMod val="85000"/>
                  <a:lumOff val="15000"/>
                </a:schemeClr>
              </a:solidFill>
              <a:latin typeface="Myriad Pro" pitchFamily="34" charset="0"/>
            </a:endParaRPr>
          </a:p>
        </p:txBody>
      </p:sp>
      <p:pic>
        <p:nvPicPr>
          <p:cNvPr id="1030" name="Picture 6" descr="C:\Users\Amanda\Documents\Abstracts &amp; Publications\JAI #2 Nov 2012\REsubmission March 6\Revision February 2013\Screen shots\Track Symptom Part 1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6400" y="1540948"/>
            <a:ext cx="5727395" cy="52363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766263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Users\Amanda\Documents\Abstracts &amp; Publications\JAI #2 Nov 2012\REsubmission March 6\Revision February 2013\Screen shots\Track Symptom Part 2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1"/>
          <a:stretch/>
        </p:blipFill>
        <p:spPr bwMode="auto">
          <a:xfrm>
            <a:off x="1249250" y="1485455"/>
            <a:ext cx="6904149" cy="5302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810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CA" dirty="0" smtClean="0"/>
              <a:t>SymptomGuide</a:t>
            </a:r>
            <a:r>
              <a:rPr lang="en-CA" baseline="30000" dirty="0" smtClean="0"/>
              <a:t>TM</a:t>
            </a:r>
            <a:r>
              <a:rPr lang="en-CA" dirty="0" smtClean="0"/>
              <a:t> Frequency </a:t>
            </a:r>
            <a:br>
              <a:rPr lang="en-CA" dirty="0" smtClean="0"/>
            </a:br>
            <a:r>
              <a:rPr lang="en-CA" dirty="0" smtClean="0"/>
              <a:t>&amp; Symptom Tracking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034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</TotalTime>
  <Words>27</Words>
  <Application>Microsoft Office PowerPoint</Application>
  <PresentationFormat>On-screen Show (4:3)</PresentationFormat>
  <Paragraphs>11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Multimedia Appendix 1</vt:lpstr>
      <vt:lpstr>SymptomGuideTM Portal </vt:lpstr>
      <vt:lpstr>SymptomGuideTM Health Status Sample Information</vt:lpstr>
      <vt:lpstr>SymptomGuideTM  Symptom Selection</vt:lpstr>
      <vt:lpstr>SymptomGuideTM  Symptom Descriptors </vt:lpstr>
      <vt:lpstr>SymptomGuideTM Frequency  &amp; Symptom Tracking 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1</dc:title>
  <dc:creator>Amanda Simpson</dc:creator>
  <cp:lastModifiedBy>Amanda Simpson</cp:lastModifiedBy>
  <cp:revision>6</cp:revision>
  <dcterms:created xsi:type="dcterms:W3CDTF">2013-03-13T14:05:57Z</dcterms:created>
  <dcterms:modified xsi:type="dcterms:W3CDTF">2013-03-13T18:32:51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